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245225" cy="82296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35600" cy="986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14560" y="-36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963440" y="739440"/>
            <a:ext cx="2808360" cy="3700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37080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14560" y="937080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0AE479-F93F-42AA-AC01-48FAC8A67D4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7"/>
          <p:cNvSpPr/>
          <p:nvPr/>
        </p:nvSpPr>
        <p:spPr>
          <a:xfrm>
            <a:off x="381492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BA0806-A4A2-43A7-891A-EDCC85E929E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1"/>
          <p:cNvSpPr>
            <a:spLocks noGrp="1"/>
          </p:cNvSpPr>
          <p:nvPr>
            <p:ph type="sldImg"/>
          </p:nvPr>
        </p:nvSpPr>
        <p:spPr>
          <a:xfrm>
            <a:off x="1963800" y="739800"/>
            <a:ext cx="2808360" cy="3700440"/>
          </a:xfrm>
          <a:prstGeom prst="rect">
            <a:avLst/>
          </a:prstGeom>
          <a:ln w="0">
            <a:noFill/>
          </a:ln>
        </p:spPr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96A7AC-7EC3-4D1A-9DCE-1CA4BB173A9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2480" y="330120"/>
            <a:ext cx="5621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2480" y="1920960"/>
            <a:ext cx="56214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2480" y="4758480"/>
            <a:ext cx="56214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F88477-4478-4156-BD36-8FC08882D3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2480" y="330120"/>
            <a:ext cx="5621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2480" y="1920960"/>
            <a:ext cx="27432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93200" y="1920960"/>
            <a:ext cx="27432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2480" y="4758480"/>
            <a:ext cx="27432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93200" y="4758480"/>
            <a:ext cx="27432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34A151-2396-4765-B427-3D7B0464B1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2480" y="330120"/>
            <a:ext cx="5621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2480" y="1920960"/>
            <a:ext cx="18097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12920" y="1920960"/>
            <a:ext cx="18097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13720" y="1920960"/>
            <a:ext cx="18097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2480" y="4758480"/>
            <a:ext cx="18097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12920" y="4758480"/>
            <a:ext cx="18097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13720" y="4758480"/>
            <a:ext cx="18097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CFCF0-D383-404B-A3C3-732F2572DEB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2480" y="330120"/>
            <a:ext cx="5621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2480" y="1920960"/>
            <a:ext cx="5621400" cy="5432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4F80F-548B-4C30-A2DF-F90F7DEDCC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2480" y="330120"/>
            <a:ext cx="5621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2480" y="1920960"/>
            <a:ext cx="562140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9FBB4D-1759-4F2B-96A6-3CF97D82DD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2480" y="330120"/>
            <a:ext cx="5621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2480" y="1920960"/>
            <a:ext cx="274320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93200" y="1920960"/>
            <a:ext cx="274320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6E8BB7-7F69-453D-83D1-D3CFE0A780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2480" y="330120"/>
            <a:ext cx="5621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36EEB-460D-4AFA-89FC-AD5E856EC6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2480" y="330120"/>
            <a:ext cx="562140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A3E38-A5A9-4EDC-9E77-56DE6DEB5C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2480" y="330120"/>
            <a:ext cx="5621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2480" y="1920960"/>
            <a:ext cx="27432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93200" y="1920960"/>
            <a:ext cx="274320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2480" y="4758480"/>
            <a:ext cx="27432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D2837-7511-4C85-827B-E8DEC6121A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2480" y="330120"/>
            <a:ext cx="5621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2480" y="1920960"/>
            <a:ext cx="274320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93200" y="1920960"/>
            <a:ext cx="27432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93200" y="4758480"/>
            <a:ext cx="27432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B775E-93F0-43E7-9437-FE1395DE13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2480" y="330120"/>
            <a:ext cx="5621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2480" y="1920960"/>
            <a:ext cx="27432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93200" y="1920960"/>
            <a:ext cx="27432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2480" y="4758480"/>
            <a:ext cx="56214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A76D28-E728-436A-B16E-995AB02899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2480" y="330120"/>
            <a:ext cx="5621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2480" y="1920960"/>
            <a:ext cx="562140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335880" indent="-3358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27920" indent="-280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19960" indent="-22392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68160" indent="-2239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16000" indent="-2239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16000" indent="-2239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16000" indent="-2239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2840" y="7495920"/>
            <a:ext cx="1457280" cy="57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33360" y="7495920"/>
            <a:ext cx="1979640" cy="57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76240" y="7495920"/>
            <a:ext cx="1457640" cy="57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922F1D-9650-4A37-8556-AB942F395C1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5"/>
          <p:cNvSpPr/>
          <p:nvPr/>
        </p:nvSpPr>
        <p:spPr>
          <a:xfrm>
            <a:off x="617040" y="11160"/>
            <a:ext cx="2777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able S1.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Oligo DNA sequence used in this study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9"/>
          <p:cNvSpPr/>
          <p:nvPr/>
        </p:nvSpPr>
        <p:spPr>
          <a:xfrm>
            <a:off x="430200" y="360360"/>
            <a:ext cx="538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8"/>
          <p:cNvSpPr/>
          <p:nvPr/>
        </p:nvSpPr>
        <p:spPr>
          <a:xfrm>
            <a:off x="430200" y="3591000"/>
            <a:ext cx="538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7"/>
          <p:cNvSpPr/>
          <p:nvPr/>
        </p:nvSpPr>
        <p:spPr>
          <a:xfrm>
            <a:off x="438120" y="4587840"/>
            <a:ext cx="538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1"/>
          <p:cNvSpPr/>
          <p:nvPr/>
        </p:nvSpPr>
        <p:spPr>
          <a:xfrm>
            <a:off x="3679920" y="183600"/>
            <a:ext cx="761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quence (5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</a:t>
            </a:r>
            <a:r>
              <a:rPr b="1" lang="en-US" sz="600" spc="-1" strike="noStrike">
                <a:solidFill>
                  <a:srgbClr val="000000"/>
                </a:solidFill>
                <a:latin typeface="ＭＳ 明朝"/>
                <a:ea typeface="ＭＳ 明朝"/>
              </a:rPr>
              <a:t>➝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3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2"/>
          <p:cNvSpPr/>
          <p:nvPr/>
        </p:nvSpPr>
        <p:spPr>
          <a:xfrm>
            <a:off x="752040" y="262080"/>
            <a:ext cx="4509000" cy="322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-Primer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GTCACATTTTCATTATTTTTATTATAAGGCCTGCTGAAAATG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-Primer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CGTCCACAAAATGATTCTGAATTAGCTGTATC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12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AGGCCG_CTGGCGTAGGCAAG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GTGGCGTAGGCAAG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AATATAAACTTGTGGTAGTTGGAGCTG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12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AGGCCG_TGTGGCGTAGGCAA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GGTGGCGTAGGC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GAATATAAACTTGTGGTAGTTGGAGCT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12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AGGCCG_ATGGCGTAGGCAAGA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GTGGCGTAGGCAAG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AATATAAACTTGTGGTAGTTGGAGCTG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12R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AGGCCG_CGTGGCGTAGGC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GTGGCGTAGGCAAG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AATATAAACTTGTGGTAGTTGGAGCTG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12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AGGCCG_AGTGGCGTAGGCAA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GGTGGCGTAGGC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GAATATAAACTTGTGGTAGTTGGAGCT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12V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AGGCCG_TTGGCGTAGGCAAGA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GTGGCGTAGGCAAG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AATATAAACTTGTGGTAGTTGGAGCTG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13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AGGCCG_ACGTAGGCAAGAGTGC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GCGTAGGCAAGAGTG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TGTGGTAGTTGGAGCTGGTG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RET (Arm 6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AM-TCT-Q-AGCCGGTTTTCCGGCTGAGA_CGGCCTCGCG-NH</a:t>
            </a:r>
            <a:r>
              <a:rPr b="0" lang="en-US" sz="600" spc="-1" strike="noStrike" baseline="-30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RET (Arm 3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ED-TCT-Q-TCGGCCTTTTGGCCGAGAGA_CTCCGCGTCCGT-NH</a:t>
            </a:r>
            <a:r>
              <a:rPr b="0" lang="en-US" sz="600" spc="-1" strike="noStrike" baseline="-30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3"/>
          <p:cNvSpPr/>
          <p:nvPr/>
        </p:nvSpPr>
        <p:spPr>
          <a:xfrm>
            <a:off x="752040" y="3548160"/>
            <a:ext cx="4509000" cy="88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-Primer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GAGATCTACTGTTTTCCTTTACTTACTACACCTCAGA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-Primer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AAAATGGATCCAGACAACTGTTCAAACTGAT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V600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CCGAGG_TCTGTAGCTAGACCAAAATC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ACTGTAGCTAGACCAAAATC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GACCCACTCCATCGAGATTTC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RET (Arm 1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AM-TCT-Q-AGCCGGTTTTCCGGCTGAGA_</a:t>
            </a:r>
            <a:r>
              <a:rPr b="0" lang="en-US" sz="600" spc="-1" strike="noStrike">
                <a:solidFill>
                  <a:srgbClr val="000000"/>
                </a:solidFill>
                <a:latin typeface="Century"/>
                <a:ea typeface="ＭＳ 明朝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CTCGGCGCG-NH</a:t>
            </a:r>
            <a:r>
              <a:rPr b="0" lang="en-US" sz="600" spc="-1" strike="noStrike" baseline="-30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RET (Arm 3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ED-TCT-Q-TCGGCCTTTTGGCCGAGAGA_CTCCGCGTCCGT-NH</a:t>
            </a:r>
            <a:r>
              <a:rPr b="0" lang="en-US" sz="600" spc="-1" strike="noStrike" baseline="-30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4"/>
          <p:cNvSpPr/>
          <p:nvPr/>
        </p:nvSpPr>
        <p:spPr>
          <a:xfrm>
            <a:off x="753120" y="4514760"/>
            <a:ext cx="4521240" cy="262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-Primer (exon9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GAAAATGACAAAGAACAGCTCAAAGCAATTTC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-Primer (exon9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ATAGGTATGGTAAAAACATGCTGAGATCAGCCAAA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E542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TAGAGAGAGGATCTCGTG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CCGAGG_CAGAGAGAGGATCTCGT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AAAATCTTTCTCCTGCTCAGTGATT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E545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TAGTGATTTCAGAGAGAGGA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CCGAGG_CAGTGATTTCAGAGAGAGG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ACTCCATAGAAAATCTTTCTCCTGCT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E545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CCAGTGATTTCAGAGAGAG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CCGAGG_TCAGTGATTTCAGAGAGAG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GACTCCATAGAAAATCTTTCTCCTGC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-Primer (exon20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TGAGCAAGAGGCTTTGGAGTATTTC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-Primer (exon20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CTCAGTTATCTTTTCAGTTCAATGCATGCTGT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H1047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CGTGCATCATTCATTTGT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CCGAGG TGTGCATCATTCATTTGTTT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TGTTGTCCAGCCACCATGA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H1047R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M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GGACGCGGAG_AGTGCATCATTCATTTGTTT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 (Wt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CCGAGG_TGTGCATCATTCATTTGTTT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TGTTGTCCAGCCACCATGA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RET (Arm 3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AM-TCT-Q-AGCCGGTTTTCCGGCTGAGA_CTCCGCGTCCGT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RET (Arm 1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ED-TCT-Q-TCGGCCTTTTGGCCGAGAGA_</a:t>
            </a:r>
            <a:r>
              <a:rPr b="0" lang="en-US" sz="600" spc="-1" strike="noStrike">
                <a:solidFill>
                  <a:srgbClr val="000000"/>
                </a:solidFill>
                <a:latin typeface="Century"/>
                <a:ea typeface="ＭＳ 明朝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CTCGGCGCG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5"/>
          <p:cNvSpPr/>
          <p:nvPr/>
        </p:nvSpPr>
        <p:spPr>
          <a:xfrm>
            <a:off x="753480" y="7200000"/>
            <a:ext cx="4451040" cy="57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-Primer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TCCACCGTTCTTTCTTACCGCACT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-Primer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CCCCAGTCTCCAAAAATCCGATTG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llele Probe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GCGCCGAGG_TGCTAAAATGCATCACCA-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Invader Oligo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TGTTGTCCAGCCACCATGA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RET (Arm 1)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AM-TCT-Q-AGCCGGTTTTCCGGCTGAGA_</a:t>
            </a:r>
            <a:r>
              <a:rPr b="0" lang="en-US" sz="600" spc="-1" strike="noStrike">
                <a:solidFill>
                  <a:srgbClr val="000000"/>
                </a:solidFill>
                <a:latin typeface="Century"/>
                <a:ea typeface="ＭＳ 明朝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CTCGGCGCG-NH</a:t>
            </a:r>
            <a:r>
              <a:rPr b="0" lang="en-US" sz="600" spc="-1" strike="noStrike" baseline="-30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6"/>
          <p:cNvSpPr/>
          <p:nvPr/>
        </p:nvSpPr>
        <p:spPr>
          <a:xfrm>
            <a:off x="817200" y="183600"/>
            <a:ext cx="69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KRAS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mutat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7"/>
          <p:cNvSpPr/>
          <p:nvPr/>
        </p:nvSpPr>
        <p:spPr>
          <a:xfrm>
            <a:off x="3679920" y="3406320"/>
            <a:ext cx="761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quence (5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</a:t>
            </a:r>
            <a:r>
              <a:rPr b="1" lang="en-US" sz="600" spc="-1" strike="noStrike">
                <a:solidFill>
                  <a:srgbClr val="000000"/>
                </a:solidFill>
                <a:latin typeface="ＭＳ 明朝"/>
                <a:ea typeface="ＭＳ 明朝"/>
              </a:rPr>
              <a:t>➝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3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8"/>
          <p:cNvSpPr/>
          <p:nvPr/>
        </p:nvSpPr>
        <p:spPr>
          <a:xfrm>
            <a:off x="817200" y="3406320"/>
            <a:ext cx="700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BRAF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mutat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9"/>
          <p:cNvSpPr/>
          <p:nvPr/>
        </p:nvSpPr>
        <p:spPr>
          <a:xfrm>
            <a:off x="3679920" y="4403160"/>
            <a:ext cx="761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quence (5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</a:t>
            </a:r>
            <a:r>
              <a:rPr b="1" lang="en-US" sz="600" spc="-1" strike="noStrike">
                <a:solidFill>
                  <a:srgbClr val="000000"/>
                </a:solidFill>
                <a:latin typeface="ＭＳ 明朝"/>
                <a:ea typeface="ＭＳ 明朝"/>
              </a:rPr>
              <a:t>➝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3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30"/>
          <p:cNvSpPr/>
          <p:nvPr/>
        </p:nvSpPr>
        <p:spPr>
          <a:xfrm>
            <a:off x="816840" y="4403160"/>
            <a:ext cx="764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IK3CA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mutat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31"/>
          <p:cNvSpPr/>
          <p:nvPr/>
        </p:nvSpPr>
        <p:spPr>
          <a:xfrm>
            <a:off x="407880" y="7213680"/>
            <a:ext cx="538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32"/>
          <p:cNvSpPr/>
          <p:nvPr/>
        </p:nvSpPr>
        <p:spPr>
          <a:xfrm>
            <a:off x="3649680" y="7029000"/>
            <a:ext cx="761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quence (5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</a:t>
            </a:r>
            <a:r>
              <a:rPr b="1" lang="en-US" sz="600" spc="-1" strike="noStrike">
                <a:solidFill>
                  <a:srgbClr val="000000"/>
                </a:solidFill>
                <a:latin typeface="ＭＳ 明朝"/>
                <a:ea typeface="ＭＳ 明朝"/>
              </a:rPr>
              <a:t>➝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3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33"/>
          <p:cNvSpPr/>
          <p:nvPr/>
        </p:nvSpPr>
        <p:spPr>
          <a:xfrm>
            <a:off x="785520" y="7029000"/>
            <a:ext cx="688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ositive contr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34"/>
          <p:cNvSpPr/>
          <p:nvPr/>
        </p:nvSpPr>
        <p:spPr>
          <a:xfrm>
            <a:off x="407880" y="7788240"/>
            <a:ext cx="538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26"/>
          <p:cNvSpPr/>
          <p:nvPr/>
        </p:nvSpPr>
        <p:spPr>
          <a:xfrm>
            <a:off x="459720" y="7768800"/>
            <a:ext cx="613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Q = Quencher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6"/>
          <p:cNvSpPr/>
          <p:nvPr/>
        </p:nvSpPr>
        <p:spPr>
          <a:xfrm>
            <a:off x="374400" y="7871760"/>
            <a:ext cx="959760" cy="19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N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ＭＳ 明朝"/>
              </a:rPr>
              <a:t>2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= 3’-amino modifier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2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20T10:28:37Z</dcterms:created>
  <dc:creator>LS</dc:creator>
  <dc:description/>
  <dc:language>en-US</dc:language>
  <cp:lastModifiedBy>LS</cp:lastModifiedBy>
  <dcterms:modified xsi:type="dcterms:W3CDTF">2013-04-04T00:55:35Z</dcterms:modified>
  <cp:revision>56</cp:revision>
  <dc:subject/>
  <dc:title>スライド 1</dc:title>
</cp:coreProperties>
</file>